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2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6776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978080" y="250164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7764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6776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978080" y="5740560"/>
            <a:ext cx="219024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77640" y="426240"/>
            <a:ext cx="6803280" cy="82749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863880" y="574056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US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863880" y="2501640"/>
            <a:ext cx="331992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77640" y="5740560"/>
            <a:ext cx="6803280" cy="2957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426240"/>
            <a:ext cx="6803280" cy="17848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r>
              <a:rPr b="0" lang="en-US" sz="4400" spc="-1" strike="noStrike">
                <a:latin typeface="Arial"/>
              </a:rPr>
              <a:t>Clique para editar o formato do texto do título</a:t>
            </a:r>
            <a:endParaRPr b="0" lang="en-US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7640" y="2501640"/>
            <a:ext cx="6803280" cy="62006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3200" spc="-1" strike="noStrike">
                <a:latin typeface="Arial"/>
              </a:rPr>
              <a:t>Clique para editar o formato do texto da estrutura de tópicos</a:t>
            </a:r>
            <a:endParaRPr b="0" lang="en-US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800" spc="-1" strike="noStrike">
                <a:latin typeface="Arial"/>
              </a:rPr>
              <a:t>2.º nível da estrutura de tópicos</a:t>
            </a:r>
            <a:endParaRPr b="0" lang="en-US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400" spc="-1" strike="noStrike">
                <a:latin typeface="Arial"/>
              </a:rPr>
              <a:t>3.º nível da estrutura de tópicos</a:t>
            </a:r>
            <a:endParaRPr b="0" lang="en-US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latin typeface="Arial"/>
              </a:rPr>
              <a:t>4.º nível da estrutura de tópicos</a:t>
            </a:r>
            <a:endParaRPr b="0" lang="en-US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5.º nível da estrutura de tópicos</a:t>
            </a:r>
            <a:endParaRPr b="0" lang="en-US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6.º nível da estrutura de tópicos</a:t>
            </a:r>
            <a:endParaRPr b="0" lang="en-US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latin typeface="Arial"/>
              </a:rPr>
              <a:t>7.º nível da estrutura de tópicos</a:t>
            </a:r>
            <a:endParaRPr b="0" lang="en-US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491760" y="7176600"/>
            <a:ext cx="6552720" cy="17859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 algn="just">
              <a:lnSpc>
                <a:spcPct val="100000"/>
              </a:lnSpc>
            </a:pPr>
            <a:r>
              <a:rPr b="1" lang="en-US" sz="1200" spc="-1" strike="noStrike">
                <a:solidFill>
                  <a:srgbClr val="202124"/>
                </a:solidFill>
                <a:latin typeface="Calibri"/>
                <a:ea typeface="Times New Roman"/>
              </a:rPr>
              <a:t>Supplementary Figure S1. Overview of cohort features. We showed the distribution (%) of the main cohort features presented in this study. </a:t>
            </a:r>
            <a:r>
              <a:rPr b="0" lang="en-US" sz="1200" spc="-1" strike="noStrike">
                <a:solidFill>
                  <a:srgbClr val="202124"/>
                </a:solidFill>
                <a:latin typeface="Calibri"/>
                <a:ea typeface="Times New Roman"/>
              </a:rPr>
              <a:t>(A) Distribution of age, sex and the most common symptoms reported for the patients; (B) chromosomal distribution of the genes and inheritance patterns found in our cohort; (C) Informations about the consequence, ACMG pathogenicity, and zygosity of the patient variants; (D) IEI classes adopted by the IUIS Expert Committee associated with the monogenic gene defects in our cohort. (abbreviation: AD - Autosomal dominant; AR - Autosomal recessive; XLR - X-linked recessive; VUS - Variant of Uncertain Significance)</a:t>
            </a:r>
            <a:endParaRPr b="0" lang="en-US" sz="1200" spc="-1" strike="noStrike">
              <a:latin typeface="Arial"/>
            </a:endParaRPr>
          </a:p>
        </p:txBody>
      </p:sp>
      <p:pic>
        <p:nvPicPr>
          <p:cNvPr id="39" name="" descr=""/>
          <p:cNvPicPr/>
          <p:nvPr/>
        </p:nvPicPr>
        <p:blipFill>
          <a:blip r:embed="rId1"/>
          <a:stretch/>
        </p:blipFill>
        <p:spPr>
          <a:xfrm>
            <a:off x="369000" y="1203840"/>
            <a:ext cx="6797880" cy="578304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6.4.7.2$Linux_X86_64 LibreOffice_project/4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1-06T16:22:28Z</dcterms:created>
  <dc:creator/>
  <dc:description/>
  <dc:language>pt-BR</dc:language>
  <cp:lastModifiedBy/>
  <dcterms:modified xsi:type="dcterms:W3CDTF">2023-07-31T15:07:48Z</dcterms:modified>
  <cp:revision>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</Properties>
</file>